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197"/>
  </p:normalViewPr>
  <p:slideViewPr>
    <p:cSldViewPr snapToGrid="0" snapToObjects="1">
      <p:cViewPr varScale="1">
        <p:scale>
          <a:sx n="119" d="100"/>
          <a:sy n="119" d="100"/>
        </p:scale>
        <p:origin x="21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E9550E-A3D5-1E45-A32A-42D8AEC3A31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35E282E-57CA-CC49-90AF-6204AD057E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21E7A2-08FE-3144-B04D-FBEC77FFA4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B8488-A466-BD4A-912A-FE521BCC7347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500D4C-CE62-0848-A7B5-B559AA30C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93B751-8CE5-9648-9583-10259E84AB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11BDF-4917-3A45-A803-2EE9CE5E8C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0539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8181B7-735D-9346-B6D4-27EF1EAE93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2B2F387-67A9-CC4E-9295-A1F14A9369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AD4CDF-278D-AA47-BEA6-077C004BE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B8488-A466-BD4A-912A-FE521BCC7347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E88CD2-FD7B-804C-AA23-7EF10DCED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2B129D-5ADF-9048-94C2-1F875AB730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11BDF-4917-3A45-A803-2EE9CE5E8C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0814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F9C7508-855A-404F-839C-E8639D3200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83062B-25E8-AA4C-B5E4-15A1196170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1F27D0-B7BE-2848-BBB0-A2A45561B1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B8488-A466-BD4A-912A-FE521BCC7347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948722-9850-454A-AE0C-D610D9DA2C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E378DB-76C9-CF4D-BE94-F0983E4ADB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11BDF-4917-3A45-A803-2EE9CE5E8C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0212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14DAF9-0A6A-164F-963A-E907E807BA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346B2E-6C4C-4D47-8F26-6D4E6D46D1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08E6B5-3973-BF48-B29F-633597DC20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B8488-A466-BD4A-912A-FE521BCC7347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9CB420-2E70-3944-AE19-97912FAB1F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E6F232-FA69-C940-BF55-AA862E9DB1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11BDF-4917-3A45-A803-2EE9CE5E8C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69681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A07D48-4BDB-EA4A-ADB1-E528F23C69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345729-7E9C-FB48-BABF-A78A2A4762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64EF54-8530-3B41-9D0A-2F8B305089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B8488-A466-BD4A-912A-FE521BCC7347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0889BA-2061-7942-B759-CC60CAC724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D057EC-ABED-A04D-9738-9E1054F04E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11BDF-4917-3A45-A803-2EE9CE5E8C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09732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22B77D-65F5-3040-A313-322593CCD9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862DB0-D3B7-E848-95DB-668A9E63D7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2C29D3-EF1A-F343-87D6-6FF4BAD8C8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D29952-82A8-D540-A362-2A0684166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B8488-A466-BD4A-912A-FE521BCC7347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A21117-2D24-0D42-9E84-6E75365AEE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BBB165-84C3-4B4E-997B-4E2B99A1A7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11BDF-4917-3A45-A803-2EE9CE5E8C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317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059B7A-C4C0-BA41-A1C7-DCC2D4FAB3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119D2A-0E3C-5048-9DA5-DA8A90C29A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686A31-2AC2-0C4D-B364-E7525E4A7A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01B848A-D6E7-D24A-9A05-65836BD50A7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EF9617E-98DE-2D43-B395-049B103693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FE26D0F-34BB-B344-B0D3-C049037CAA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B8488-A466-BD4A-912A-FE521BCC7347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DA3C11B-85AC-3C40-A556-AF4FFBE01E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74CE7B6-702F-8B4C-8D30-1CE2D5F6A3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11BDF-4917-3A45-A803-2EE9CE5E8C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3331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829ADE-7837-FC43-B358-138FE00158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4ED10A8-AE78-9246-B564-9C29C2CD6F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B8488-A466-BD4A-912A-FE521BCC7347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8BCCCE-0B8E-804B-A9D0-02421EB51E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4AF3625-6A61-8343-8C0F-F6023E0501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11BDF-4917-3A45-A803-2EE9CE5E8C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73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93615C-CFEF-AE43-8DBE-42B0093D60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B8488-A466-BD4A-912A-FE521BCC7347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CB8C3C7-07DB-C744-B786-D18E0A949F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C8C444B-588F-A843-9831-6F80EC58F9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11BDF-4917-3A45-A803-2EE9CE5E8C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713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CCD9F1-3973-FF45-9DC5-F1AF7B39AA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1532AE-4D5D-6646-9F09-8DABBF22F0B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0320092-BD9E-974E-A4A4-1B3ABC444DB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CEFD79-9901-7F4D-9A52-E7248230AB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B8488-A466-BD4A-912A-FE521BCC7347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99D785-B525-924B-A162-D9A80CED48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E4DF56-E7A6-8243-844F-881EF808A1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11BDF-4917-3A45-A803-2EE9CE5E8C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82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255ED7-9E3E-0A46-A9EC-2A09B06679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8C5E029-1BB4-DB4E-BF78-1123A2ED13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75E408-9995-FD45-8578-E3C3206BAC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BC3B2C-2A6E-184D-A623-F1B8455AE8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B8488-A466-BD4A-912A-FE521BCC7347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468DBE-D4B2-4D4C-A020-E1A14D327C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F41159-0925-434E-AD17-B714E2815A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11BDF-4917-3A45-A803-2EE9CE5E8C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50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A145F29-3FA0-3749-B3A9-2C8CBE9C7D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26948D-B767-9B4D-B7C9-2BC054A12D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F634FA-88B0-E444-8F2D-5F521285086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BB8488-A466-BD4A-912A-FE521BCC7347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D396F4-5D72-D34A-B821-5827198E413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428672-A105-CA43-B063-4E3AE8C1E1D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511BDF-4917-3A45-A803-2EE9CE5E8C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708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4808425D-B570-9145-BB0A-57FE318C062F}"/>
              </a:ext>
            </a:extLst>
          </p:cNvPr>
          <p:cNvGrpSpPr/>
          <p:nvPr/>
        </p:nvGrpSpPr>
        <p:grpSpPr>
          <a:xfrm>
            <a:off x="3505311" y="458052"/>
            <a:ext cx="5181377" cy="5941895"/>
            <a:chOff x="3043091" y="779024"/>
            <a:chExt cx="5181377" cy="5941895"/>
          </a:xfrm>
        </p:grpSpPr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63C60C90-CF5D-EE41-88A0-3C8436FFFC5B}"/>
                </a:ext>
              </a:extLst>
            </p:cNvPr>
            <p:cNvSpPr txBox="1"/>
            <p:nvPr/>
          </p:nvSpPr>
          <p:spPr>
            <a:xfrm>
              <a:off x="3334585" y="779024"/>
              <a:ext cx="130997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CDC93 </a:t>
              </a:r>
              <a:r>
                <a: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cleotide</a:t>
              </a: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45209F33-5ADC-DD4A-B7AF-3B414EEC42A8}"/>
                </a:ext>
              </a:extLst>
            </p:cNvPr>
            <p:cNvGrpSpPr/>
            <p:nvPr/>
          </p:nvGrpSpPr>
          <p:grpSpPr>
            <a:xfrm>
              <a:off x="3043091" y="1129631"/>
              <a:ext cx="5181377" cy="5591288"/>
              <a:chOff x="69655" y="852347"/>
              <a:chExt cx="6908502" cy="7455051"/>
            </a:xfrm>
          </p:grpSpPr>
          <p:grpSp>
            <p:nvGrpSpPr>
              <p:cNvPr id="54" name="Group 53">
                <a:extLst>
                  <a:ext uri="{FF2B5EF4-FFF2-40B4-BE49-F238E27FC236}">
                    <a16:creationId xmlns:a16="http://schemas.microsoft.com/office/drawing/2014/main" id="{FF5ECFCD-6C33-9F43-B6FB-EB20BADC7E6F}"/>
                  </a:ext>
                </a:extLst>
              </p:cNvPr>
              <p:cNvGrpSpPr/>
              <p:nvPr/>
            </p:nvGrpSpPr>
            <p:grpSpPr>
              <a:xfrm>
                <a:off x="69655" y="852347"/>
                <a:ext cx="4136070" cy="7455051"/>
                <a:chOff x="-682" y="852347"/>
                <a:chExt cx="4974271" cy="7455051"/>
              </a:xfrm>
            </p:grpSpPr>
            <p:pic>
              <p:nvPicPr>
                <p:cNvPr id="63" name="Picture 62">
                  <a:extLst>
                    <a:ext uri="{FF2B5EF4-FFF2-40B4-BE49-F238E27FC236}">
                      <a16:creationId xmlns:a16="http://schemas.microsoft.com/office/drawing/2014/main" id="{437AF542-54AD-4849-8E02-774189903A6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-682" y="852347"/>
                  <a:ext cx="4974271" cy="7455051"/>
                </a:xfrm>
                <a:prstGeom prst="rect">
                  <a:avLst/>
                </a:prstGeom>
              </p:spPr>
            </p:pic>
            <p:sp>
              <p:nvSpPr>
                <p:cNvPr id="53" name="Rectangle 52">
                  <a:extLst>
                    <a:ext uri="{FF2B5EF4-FFF2-40B4-BE49-F238E27FC236}">
                      <a16:creationId xmlns:a16="http://schemas.microsoft.com/office/drawing/2014/main" id="{12078A49-B971-C349-937C-4299C81EF207}"/>
                    </a:ext>
                  </a:extLst>
                </p:cNvPr>
                <p:cNvSpPr/>
                <p:nvPr/>
              </p:nvSpPr>
              <p:spPr>
                <a:xfrm>
                  <a:off x="3273075" y="1051520"/>
                  <a:ext cx="113721" cy="43044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350"/>
                </a:p>
              </p:txBody>
            </p:sp>
          </p:grp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113E2081-4DEA-3F4F-B7F5-301B63FB0093}"/>
                  </a:ext>
                </a:extLst>
              </p:cNvPr>
              <p:cNvSpPr txBox="1"/>
              <p:nvPr/>
            </p:nvSpPr>
            <p:spPr>
              <a:xfrm>
                <a:off x="2221522" y="863904"/>
                <a:ext cx="4176785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elaginella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ellendorffii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elaginell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ycophyta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4B309ED9-5181-EB40-9C54-ABF372A32DE2}"/>
                  </a:ext>
                </a:extLst>
              </p:cNvPr>
              <p:cNvSpPr txBox="1"/>
              <p:nvPr/>
            </p:nvSpPr>
            <p:spPr>
              <a:xfrm>
                <a:off x="1208430" y="7663273"/>
                <a:ext cx="3680923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ratodon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urpureas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itrich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yophyta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483CE927-CEAA-824C-9A76-F7B970D3D5B6}"/>
                  </a:ext>
                </a:extLst>
              </p:cNvPr>
              <p:cNvSpPr txBox="1"/>
              <p:nvPr/>
            </p:nvSpPr>
            <p:spPr>
              <a:xfrm>
                <a:off x="1250634" y="7384911"/>
                <a:ext cx="3687335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yscomitrella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atens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unari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yophyta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1EEDCBEB-AF4D-3249-B951-2CA93612A214}"/>
                  </a:ext>
                </a:extLst>
              </p:cNvPr>
              <p:cNvSpPr txBox="1"/>
              <p:nvPr/>
            </p:nvSpPr>
            <p:spPr>
              <a:xfrm>
                <a:off x="2792964" y="1138436"/>
                <a:ext cx="2481876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eta vulgaris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maranth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5F3759AB-7F6F-C549-BAD1-51282B31CEF7}"/>
                  </a:ext>
                </a:extLst>
              </p:cNvPr>
              <p:cNvSpPr txBox="1"/>
              <p:nvPr/>
            </p:nvSpPr>
            <p:spPr>
              <a:xfrm>
                <a:off x="4015380" y="1678423"/>
                <a:ext cx="2962777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alaenopsis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questris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rchid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5AAA8E93-95FC-9643-AA8F-2BD4749B6D65}"/>
                  </a:ext>
                </a:extLst>
              </p:cNvPr>
              <p:cNvSpPr txBox="1"/>
              <p:nvPr/>
            </p:nvSpPr>
            <p:spPr>
              <a:xfrm>
                <a:off x="3379851" y="1954127"/>
                <a:ext cx="2327988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sa acuminata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Musaceae)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720A3341-B999-8C4C-A40B-B771E95F07F5}"/>
                  </a:ext>
                </a:extLst>
              </p:cNvPr>
              <p:cNvSpPr txBox="1"/>
              <p:nvPr/>
            </p:nvSpPr>
            <p:spPr>
              <a:xfrm>
                <a:off x="3227773" y="1413708"/>
                <a:ext cx="2372872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laeis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uineensis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ric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6161FBFA-0A30-8142-B30A-2DD894CD22CC}"/>
                  </a:ext>
                </a:extLst>
              </p:cNvPr>
              <p:cNvSpPr txBox="1"/>
              <p:nvPr/>
            </p:nvSpPr>
            <p:spPr>
              <a:xfrm>
                <a:off x="3575675" y="2500562"/>
                <a:ext cx="2135628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lea europaea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Oleaceae)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4E92AD7B-9DC6-E64E-87A0-F0F89FA0E2E9}"/>
                  </a:ext>
                </a:extLst>
              </p:cNvPr>
              <p:cNvSpPr txBox="1"/>
              <p:nvPr/>
            </p:nvSpPr>
            <p:spPr>
              <a:xfrm>
                <a:off x="3590639" y="2222227"/>
                <a:ext cx="3140176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mborella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ichocarpa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mborell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673E2B44-A33C-9B45-A13F-28256B9A7868}"/>
                  </a:ext>
                </a:extLst>
              </p:cNvPr>
              <p:cNvSpPr txBox="1"/>
              <p:nvPr/>
            </p:nvSpPr>
            <p:spPr>
              <a:xfrm>
                <a:off x="2910027" y="3320004"/>
                <a:ext cx="1962504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itis vinifera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Vitaceae)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13885709-9752-4140-AE47-49BA1A5002FB}"/>
                  </a:ext>
                </a:extLst>
              </p:cNvPr>
              <p:cNvSpPr txBox="1"/>
              <p:nvPr/>
            </p:nvSpPr>
            <p:spPr>
              <a:xfrm>
                <a:off x="3583295" y="3031412"/>
                <a:ext cx="2545996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lianthus annuus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Asteraceae)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C37AE379-5B12-4343-A255-7F26760DEC44}"/>
                  </a:ext>
                </a:extLst>
              </p:cNvPr>
              <p:cNvSpPr txBox="1"/>
              <p:nvPr/>
            </p:nvSpPr>
            <p:spPr>
              <a:xfrm>
                <a:off x="3330696" y="2767319"/>
                <a:ext cx="2646452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olanum tuberosum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Solanaceae)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5B55827F-4A53-7948-86B1-F210E5CF7555}"/>
                  </a:ext>
                </a:extLst>
              </p:cNvPr>
              <p:cNvSpPr txBox="1"/>
              <p:nvPr/>
            </p:nvSpPr>
            <p:spPr>
              <a:xfrm>
                <a:off x="3883441" y="3587159"/>
                <a:ext cx="2554545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ucalyptus grandis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yrt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3CBEB348-A3B9-A049-8432-BC74466F0822}"/>
                  </a:ext>
                </a:extLst>
              </p:cNvPr>
              <p:cNvSpPr txBox="1"/>
              <p:nvPr/>
            </p:nvSpPr>
            <p:spPr>
              <a:xfrm>
                <a:off x="3487531" y="3851252"/>
                <a:ext cx="2858048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quilegia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erulea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Ranunculaceae)</a:t>
                </a: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FA44B269-38A4-F246-A9B2-4091DBC99040}"/>
                  </a:ext>
                </a:extLst>
              </p:cNvPr>
              <p:cNvSpPr txBox="1"/>
              <p:nvPr/>
            </p:nvSpPr>
            <p:spPr>
              <a:xfrm>
                <a:off x="3288733" y="4122967"/>
                <a:ext cx="2385696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urio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zibethinus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v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56F6EE5E-5D2F-9D48-A1F4-848A44AF628A}"/>
                  </a:ext>
                </a:extLst>
              </p:cNvPr>
              <p:cNvSpPr txBox="1"/>
              <p:nvPr/>
            </p:nvSpPr>
            <p:spPr>
              <a:xfrm>
                <a:off x="3288733" y="4390122"/>
                <a:ext cx="2667825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ossypium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irsutum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v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74BDB363-8B52-3A47-844D-6DB308F147CB}"/>
                  </a:ext>
                </a:extLst>
              </p:cNvPr>
              <p:cNvSpPr txBox="1"/>
              <p:nvPr/>
            </p:nvSpPr>
            <p:spPr>
              <a:xfrm>
                <a:off x="3525103" y="4676105"/>
                <a:ext cx="2127078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itrus sinensis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ut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188F773A-9FB6-4540-ACD9-1E2314D90CB0}"/>
                  </a:ext>
                </a:extLst>
              </p:cNvPr>
              <p:cNvSpPr txBox="1"/>
              <p:nvPr/>
            </p:nvSpPr>
            <p:spPr>
              <a:xfrm>
                <a:off x="3482340" y="5213077"/>
                <a:ext cx="2642177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opulus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ichocarpa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Salicaceae)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AA086D3F-2855-E840-BDED-2DC4B6AC28A6}"/>
                  </a:ext>
                </a:extLst>
              </p:cNvPr>
              <p:cNvSpPr txBox="1"/>
              <p:nvPr/>
            </p:nvSpPr>
            <p:spPr>
              <a:xfrm>
                <a:off x="3592096" y="4938405"/>
                <a:ext cx="2800340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nihot esculenta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uphorbi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6681E20E-E29B-AA4C-8518-77A5FB8C728B}"/>
                  </a:ext>
                </a:extLst>
              </p:cNvPr>
              <p:cNvSpPr txBox="1"/>
              <p:nvPr/>
            </p:nvSpPr>
            <p:spPr>
              <a:xfrm>
                <a:off x="3800707" y="6019323"/>
                <a:ext cx="2353636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lycine max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eguminos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CB8470F1-E801-424C-8F2E-ADE1E4886E56}"/>
                  </a:ext>
                </a:extLst>
              </p:cNvPr>
              <p:cNvSpPr txBox="1"/>
              <p:nvPr/>
            </p:nvSpPr>
            <p:spPr>
              <a:xfrm>
                <a:off x="3227765" y="5491994"/>
                <a:ext cx="2129216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Quercus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ber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Fagaceae)</a:t>
                </a: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1883A696-54D7-034E-B407-27E18116CCF5}"/>
                  </a:ext>
                </a:extLst>
              </p:cNvPr>
              <p:cNvSpPr txBox="1"/>
              <p:nvPr/>
            </p:nvSpPr>
            <p:spPr>
              <a:xfrm>
                <a:off x="3566568" y="5753827"/>
                <a:ext cx="1949680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rus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nota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raceae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7C54B91E-79A9-F94D-9902-E9A84FDB992C}"/>
                  </a:ext>
                </a:extLst>
              </p:cNvPr>
              <p:cNvSpPr txBox="1"/>
              <p:nvPr/>
            </p:nvSpPr>
            <p:spPr>
              <a:xfrm>
                <a:off x="3982576" y="6847466"/>
                <a:ext cx="2595156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phanus sativus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Brassicaceae)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A93CE39F-129B-F743-8033-3EFDD83C822D}"/>
                  </a:ext>
                </a:extLst>
              </p:cNvPr>
              <p:cNvSpPr txBox="1"/>
              <p:nvPr/>
            </p:nvSpPr>
            <p:spPr>
              <a:xfrm>
                <a:off x="3995799" y="7120435"/>
                <a:ext cx="2417756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ssica </a:t>
                </a:r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pus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Brassicaceae)</a:t>
                </a: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066811E9-EB37-FC49-9D88-AF5207A7EF7B}"/>
                  </a:ext>
                </a:extLst>
              </p:cNvPr>
              <p:cNvSpPr txBox="1"/>
              <p:nvPr/>
            </p:nvSpPr>
            <p:spPr>
              <a:xfrm>
                <a:off x="3929161" y="6571103"/>
                <a:ext cx="2875146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rabidopsis thaliana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Brassicaceae)</a:t>
                </a:r>
              </a:p>
            </p:txBody>
          </p: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659E55BB-100A-244B-8C62-489079E9DA76}"/>
                  </a:ext>
                </a:extLst>
              </p:cNvPr>
              <p:cNvSpPr txBox="1"/>
              <p:nvPr/>
            </p:nvSpPr>
            <p:spPr>
              <a:xfrm>
                <a:off x="3632797" y="6299569"/>
                <a:ext cx="2704158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ucurbis</a:t>
                </a:r>
                <a:r>
                  <a:rPr lang="en-US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axima </a:t>
                </a:r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Cucurbitaceae)</a:t>
                </a: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F68F8FD6-E90E-B04C-A561-331858ECC37B}"/>
                  </a:ext>
                </a:extLst>
              </p:cNvPr>
              <p:cNvSpPr txBox="1"/>
              <p:nvPr/>
            </p:nvSpPr>
            <p:spPr>
              <a:xfrm>
                <a:off x="3404505" y="7136921"/>
                <a:ext cx="49415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99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8F14D2E6-ED1F-274E-B65E-598FD76A64ED}"/>
                  </a:ext>
                </a:extLst>
              </p:cNvPr>
              <p:cNvSpPr txBox="1"/>
              <p:nvPr/>
            </p:nvSpPr>
            <p:spPr>
              <a:xfrm>
                <a:off x="2493739" y="6694574"/>
                <a:ext cx="49415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97</a:t>
                </a: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C6D91FE2-AA25-AB4A-A40D-BD479A5E141B}"/>
                  </a:ext>
                </a:extLst>
              </p:cNvPr>
              <p:cNvSpPr txBox="1"/>
              <p:nvPr/>
            </p:nvSpPr>
            <p:spPr>
              <a:xfrm>
                <a:off x="2332649" y="5999763"/>
                <a:ext cx="49415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95</a:t>
                </a: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9498FE0D-97C3-2F4D-9394-38E0269CDD63}"/>
                  </a:ext>
                </a:extLst>
              </p:cNvPr>
              <p:cNvSpPr txBox="1"/>
              <p:nvPr/>
            </p:nvSpPr>
            <p:spPr>
              <a:xfrm>
                <a:off x="2204945" y="5456145"/>
                <a:ext cx="49415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95</a:t>
                </a:r>
              </a:p>
            </p:txBody>
          </p:sp>
          <p:cxnSp>
            <p:nvCxnSpPr>
              <p:cNvPr id="95" name="Straight Connector 94">
                <a:extLst>
                  <a:ext uri="{FF2B5EF4-FFF2-40B4-BE49-F238E27FC236}">
                    <a16:creationId xmlns:a16="http://schemas.microsoft.com/office/drawing/2014/main" id="{A919F173-E296-944F-99CD-F8076EA9AA7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36962" y="5292992"/>
                <a:ext cx="218115" cy="22786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D3F533A0-2891-F34B-B02C-3D5E3BF5FE39}"/>
                  </a:ext>
                </a:extLst>
              </p:cNvPr>
              <p:cNvSpPr txBox="1"/>
              <p:nvPr/>
            </p:nvSpPr>
            <p:spPr>
              <a:xfrm>
                <a:off x="2713596" y="5233805"/>
                <a:ext cx="49415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99</a:t>
                </a: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8F855791-9A5F-5B4C-BF6F-76D0F39D8ADA}"/>
                  </a:ext>
                </a:extLst>
              </p:cNvPr>
              <p:cNvSpPr txBox="1"/>
              <p:nvPr/>
            </p:nvSpPr>
            <p:spPr>
              <a:xfrm>
                <a:off x="2142855" y="5138574"/>
                <a:ext cx="49415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99</a:t>
                </a:r>
              </a:p>
            </p:txBody>
          </p:sp>
          <p:cxnSp>
            <p:nvCxnSpPr>
              <p:cNvPr id="99" name="Straight Connector 98">
                <a:extLst>
                  <a:ext uri="{FF2B5EF4-FFF2-40B4-BE49-F238E27FC236}">
                    <a16:creationId xmlns:a16="http://schemas.microsoft.com/office/drawing/2014/main" id="{B4876E1B-1BB5-514E-80BF-246D514CE01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02117" y="4729457"/>
                <a:ext cx="324832" cy="495226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37608582-DCC5-1D44-9F75-B0520E38EC14}"/>
                  </a:ext>
                </a:extLst>
              </p:cNvPr>
              <p:cNvSpPr txBox="1"/>
              <p:nvPr/>
            </p:nvSpPr>
            <p:spPr>
              <a:xfrm>
                <a:off x="2130069" y="4206272"/>
                <a:ext cx="49415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92</a:t>
                </a: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6807BDD1-757D-DA42-8E62-9F392B4ACF3A}"/>
                  </a:ext>
                </a:extLst>
              </p:cNvPr>
              <p:cNvSpPr txBox="1"/>
              <p:nvPr/>
            </p:nvSpPr>
            <p:spPr>
              <a:xfrm>
                <a:off x="2568881" y="4001696"/>
                <a:ext cx="49415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90</a:t>
                </a:r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87111E45-1024-A548-939E-14003FD801BA}"/>
                  </a:ext>
                </a:extLst>
              </p:cNvPr>
              <p:cNvSpPr txBox="1"/>
              <p:nvPr/>
            </p:nvSpPr>
            <p:spPr>
              <a:xfrm>
                <a:off x="3111637" y="6931798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C00712C5-9C91-EE4C-B582-E369AAD56E4A}"/>
                  </a:ext>
                </a:extLst>
              </p:cNvPr>
              <p:cNvSpPr txBox="1"/>
              <p:nvPr/>
            </p:nvSpPr>
            <p:spPr>
              <a:xfrm>
                <a:off x="2664793" y="6060489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F07E0C82-FCC2-F24F-84AC-35E1EC940A70}"/>
                  </a:ext>
                </a:extLst>
              </p:cNvPr>
              <p:cNvSpPr txBox="1"/>
              <p:nvPr/>
            </p:nvSpPr>
            <p:spPr>
              <a:xfrm>
                <a:off x="2778729" y="4475134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DFC6A4B8-7B3A-CB46-B7DD-DEA7936F8E99}"/>
                  </a:ext>
                </a:extLst>
              </p:cNvPr>
              <p:cNvSpPr txBox="1"/>
              <p:nvPr/>
            </p:nvSpPr>
            <p:spPr>
              <a:xfrm>
                <a:off x="512474" y="7678513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C6C9EC75-157D-4146-BD8D-2CEF8D09DDA6}"/>
                  </a:ext>
                </a:extLst>
              </p:cNvPr>
              <p:cNvSpPr txBox="1"/>
              <p:nvPr/>
            </p:nvSpPr>
            <p:spPr>
              <a:xfrm>
                <a:off x="2026793" y="3600695"/>
                <a:ext cx="49415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92</a:t>
                </a: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46BA467F-652B-5143-AD65-4A0F501843EB}"/>
                  </a:ext>
                </a:extLst>
              </p:cNvPr>
              <p:cNvSpPr txBox="1"/>
              <p:nvPr/>
            </p:nvSpPr>
            <p:spPr>
              <a:xfrm>
                <a:off x="1833889" y="2846458"/>
                <a:ext cx="49415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96</a:t>
                </a: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20EC4D37-B178-AE48-ACA2-42154EDB27E0}"/>
                  </a:ext>
                </a:extLst>
              </p:cNvPr>
              <p:cNvSpPr txBox="1"/>
              <p:nvPr/>
            </p:nvSpPr>
            <p:spPr>
              <a:xfrm>
                <a:off x="2502117" y="2869110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D2D1E39C-9429-E440-858E-4CDE7959E168}"/>
                  </a:ext>
                </a:extLst>
              </p:cNvPr>
              <p:cNvSpPr txBox="1"/>
              <p:nvPr/>
            </p:nvSpPr>
            <p:spPr>
              <a:xfrm>
                <a:off x="2334317" y="3149236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7EB54B45-CD97-2041-836C-C7D384FDF0E1}"/>
                  </a:ext>
                </a:extLst>
              </p:cNvPr>
              <p:cNvSpPr txBox="1"/>
              <p:nvPr/>
            </p:nvSpPr>
            <p:spPr>
              <a:xfrm>
                <a:off x="2388720" y="1839976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01076F65-8023-CD4B-9CFB-147160D74DBF}"/>
                  </a:ext>
                </a:extLst>
              </p:cNvPr>
              <p:cNvSpPr txBox="1"/>
              <p:nvPr/>
            </p:nvSpPr>
            <p:spPr>
              <a:xfrm>
                <a:off x="1185850" y="2083802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8C985E70-257E-964C-A376-A22286E49704}"/>
                  </a:ext>
                </a:extLst>
              </p:cNvPr>
              <p:cNvSpPr txBox="1"/>
              <p:nvPr/>
            </p:nvSpPr>
            <p:spPr>
              <a:xfrm>
                <a:off x="504854" y="1555238"/>
                <a:ext cx="42362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6514442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57</Words>
  <Application>Microsoft Macintosh PowerPoint</Application>
  <PresentationFormat>Widescreen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nnor Lewis</dc:creator>
  <cp:lastModifiedBy>Connor Lewis</cp:lastModifiedBy>
  <cp:revision>2</cp:revision>
  <dcterms:created xsi:type="dcterms:W3CDTF">2022-09-13T16:50:04Z</dcterms:created>
  <dcterms:modified xsi:type="dcterms:W3CDTF">2022-11-18T19:10:19Z</dcterms:modified>
</cp:coreProperties>
</file>